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04" r:id="rId1"/>
  </p:sldMasterIdLst>
  <p:notesMasterIdLst>
    <p:notesMasterId r:id="rId3"/>
  </p:notesMasterIdLst>
  <p:handoutMasterIdLst>
    <p:handoutMasterId r:id="rId4"/>
  </p:handoutMasterIdLst>
  <p:sldIdLst>
    <p:sldId id="402" r:id="rId2"/>
  </p:sldIdLst>
  <p:sldSz cx="12192000" cy="6858000"/>
  <p:notesSz cx="9928225" cy="679767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34" autoAdjust="0"/>
    <p:restoredTop sz="94404" autoAdjust="0"/>
  </p:normalViewPr>
  <p:slideViewPr>
    <p:cSldViewPr snapToGrid="0">
      <p:cViewPr varScale="1">
        <p:scale>
          <a:sx n="80" d="100"/>
          <a:sy n="80" d="100"/>
        </p:scale>
        <p:origin x="58" y="22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quarter" idx="1"/>
          </p:nvPr>
        </p:nvSpPr>
        <p:spPr>
          <a:xfrm>
            <a:off x="5622594" y="2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F07FB4-1BBF-45E7-839D-23EC12C90DF5}" type="datetimeFigureOut">
              <a:rPr lang="zh-TW" altLang="en-US" smtClean="0"/>
              <a:t>2023/9/27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2"/>
          </p:nvPr>
        </p:nvSpPr>
        <p:spPr>
          <a:xfrm>
            <a:off x="0" y="6456380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3"/>
          </p:nvPr>
        </p:nvSpPr>
        <p:spPr>
          <a:xfrm>
            <a:off x="5622594" y="6456380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EDB775-D806-4765-93AE-1EB5168EE0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5434223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4302231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5623700" y="0"/>
            <a:ext cx="4302231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94D560-1906-4008-84E6-2CA8AC7F4D75}" type="datetimeFigureOut">
              <a:rPr lang="zh-TW" altLang="en-US" smtClean="0"/>
              <a:t>2023/9/27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925763" y="849313"/>
            <a:ext cx="4076700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992823" y="3271383"/>
            <a:ext cx="7942580" cy="267658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3" y="6456613"/>
            <a:ext cx="4302231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5623700" y="6456613"/>
            <a:ext cx="4302231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CBE8E6-A870-4E49-946C-A827C617A7B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17105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CBE8E6-A870-4E49-946C-A827C617A7B8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60654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67575C4B-59FF-4D27-924A-E9467793C5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0335FF76-F285-4903-80D0-7DFC3EB9BB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23CECF57-B004-4D13-A161-FA5047F30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332C2B0-9519-4C72-B561-8D33559E9A4B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14E13935-DA64-4B29-9E28-8BECEB8FBB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CED7A29D-817D-4E93-B5DD-89525853CF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6EDCB0-CE3F-4737-82F9-CD0E31032D9C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68870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F6619F5-E5C1-4D63-9BEA-E3CAD860DB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8A7C887E-E7CA-40A1-8D57-BAF42E79C0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0E892234-59BB-4FDB-982B-7B3647134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332C2B0-9519-4C72-B561-8D33559E9A4B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5D45B371-88BD-4AB1-ADFF-01909795E6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65328557-9FC3-42E2-A166-54C8D9846F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6EDCB0-CE3F-4737-82F9-CD0E31032D9C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251627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FDD24CB6-2597-424C-B137-C130C29C2C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2A7C84ED-354D-47FF-93A6-14E3D03400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AFEC0311-A720-4BAD-8E8A-0314E7A082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332C2B0-9519-4C72-B561-8D33559E9A4B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C3A7A68-75EC-4075-BEAE-EB4BD2D8D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58A5295A-5E09-4DF3-9ACD-8958A4958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6EDCB0-CE3F-4737-82F9-CD0E31032D9C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22062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26DFBA7-1865-42BF-AAAA-60D61A4045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1B9D2AC9-BC2C-4E27-AC88-D54BD7A06C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BB6AF345-84D7-40EA-9AD5-4DC18778CE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332C2B0-9519-4C72-B561-8D33559E9A4B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1BB507E8-FDBE-4BAD-B36B-BB23EE7A1E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73725B0F-9D5B-476E-A72C-8D1207CF9D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6EDCB0-CE3F-4737-82F9-CD0E31032D9C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600951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551749B-F938-4066-B8A2-4FEC0A7F33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33657A20-C866-4A64-9248-5B622D2887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839F448-F2D8-49DE-9471-0D86D7F434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332C2B0-9519-4C72-B561-8D33559E9A4B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822FA0D0-EEB3-45EC-A790-C371899356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0E1084CC-B489-4943-95B4-578CE681CE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6EDCB0-CE3F-4737-82F9-CD0E31032D9C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164280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EF03E0AA-3818-4B48-AE52-5AF5C0E22A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0BD68648-E9D7-41A2-B9CF-70D7B166CB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46DA5A39-ED24-40EB-88F9-85F4612567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99E9A1CF-22D4-40D7-A204-9DA34C8783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332C2B0-9519-4C72-B561-8D33559E9A4B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6D21EF86-7A50-4370-B395-E80A007F86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0582C7B8-7015-4A8D-B9A8-59A739A84A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6EDCB0-CE3F-4737-82F9-CD0E31032D9C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041932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D6F2C4AB-4537-4F23-BE81-86673E5821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0CC7CD9E-9DF0-4C90-A94C-03CA843B7A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F984CB00-0961-4A70-99E6-5CDB9AE2C1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F7288B6E-6DE0-489C-ADA7-9D342131DE7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530139BA-5839-414D-9429-B1B91EE944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5F7A2E96-A2C6-42B4-959F-BBB32CB9AF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332C2B0-9519-4C72-B561-8D33559E9A4B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F54D2B56-F50F-411F-A7AD-7150622FC5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4A63DE8B-C5A7-415F-9EE0-BD0EC4DE5E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6EDCB0-CE3F-4737-82F9-CD0E31032D9C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685667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434E4E6-3A33-4BDB-A5EB-8084479CEA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AEE0C7BF-9082-446D-AFA5-691F0DD835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332C2B0-9519-4C72-B561-8D33559E9A4B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AE29D8CF-948F-493E-B4D6-C2629261F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4B2CBDDE-4AEF-4BFC-90E4-EC5ACC73DC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6EDCB0-CE3F-4737-82F9-CD0E31032D9C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648150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2C0D87DA-59BD-4A59-AE86-6DB0635BFA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332C2B0-9519-4C72-B561-8D33559E9A4B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0CCAD612-7327-4730-BF49-593D651595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C50B3065-DE4C-4837-B91E-47191A7FB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6EDCB0-CE3F-4737-82F9-CD0E31032D9C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290327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DF4C28A3-BCE2-4EC8-AA78-EF03F018E9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5E32A2E9-11B4-4853-9DD8-7249A3DA4E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6C5AF458-8DD0-45ED-BE74-0AB86376A9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CA6CB16D-D7DB-413F-8278-E413DD1C84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332C2B0-9519-4C72-B561-8D33559E9A4B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6300326E-067F-44FE-BD7F-5CBCD38214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05E779BB-500B-439C-B640-E155796136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6EDCB0-CE3F-4737-82F9-CD0E31032D9C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482076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03122704-07AF-457C-B62B-374BD1D02B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132417E1-F1FA-4415-A260-CF077640970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E6FA16F5-947B-4BE8-9F79-B41A4258E4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307222E5-089C-4DD3-8CEB-99BC59A89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332C2B0-9519-4C72-B561-8D33559E9A4B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499BC11A-9DBB-4048-A8BB-4F31F1FF75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34FD5CC7-EB05-4FA4-8904-494BC051C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6EDCB0-CE3F-4737-82F9-CD0E31032D9C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6083883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0828D53F-A4A3-42E1-B886-4190C6727D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C41BB138-7FC3-4576-AE65-E08DDE6781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04AD81ED-BB97-4ECD-B8F0-EE78500951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7332C2B0-9519-4C72-B561-8D33559E9A4B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F177463F-2C6C-4C27-8E0B-A3A6A5F500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52350165-291C-42C7-8F6C-3F66BB3FC8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56EDCB0-CE3F-4737-82F9-CD0E31032D9C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8240619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5" r:id="rId1"/>
    <p:sldLayoutId id="2147483806" r:id="rId2"/>
    <p:sldLayoutId id="2147483807" r:id="rId3"/>
    <p:sldLayoutId id="2147483808" r:id="rId4"/>
    <p:sldLayoutId id="2147483809" r:id="rId5"/>
    <p:sldLayoutId id="2147483810" r:id="rId6"/>
    <p:sldLayoutId id="2147483811" r:id="rId7"/>
    <p:sldLayoutId id="2147483812" r:id="rId8"/>
    <p:sldLayoutId id="2147483813" r:id="rId9"/>
    <p:sldLayoutId id="2147483814" r:id="rId10"/>
    <p:sldLayoutId id="214748381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群組 52"/>
          <p:cNvGrpSpPr/>
          <p:nvPr/>
        </p:nvGrpSpPr>
        <p:grpSpPr>
          <a:xfrm>
            <a:off x="4820793" y="-3854"/>
            <a:ext cx="4986652" cy="3480953"/>
            <a:chOff x="2542032" y="-3854"/>
            <a:chExt cx="4986652" cy="3480953"/>
          </a:xfrm>
        </p:grpSpPr>
        <p:pic>
          <p:nvPicPr>
            <p:cNvPr id="45" name="圖片 4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895401" y="-3854"/>
              <a:ext cx="4633283" cy="1775402"/>
            </a:xfrm>
            <a:prstGeom prst="rect">
              <a:avLst/>
            </a:prstGeom>
          </p:spPr>
        </p:pic>
        <p:pic>
          <p:nvPicPr>
            <p:cNvPr id="46" name="圖片 4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895401" y="1725828"/>
              <a:ext cx="4633283" cy="1751271"/>
            </a:xfrm>
            <a:prstGeom prst="rect">
              <a:avLst/>
            </a:prstGeom>
          </p:spPr>
        </p:pic>
        <p:sp>
          <p:nvSpPr>
            <p:cNvPr id="51" name="文字方塊 50"/>
            <p:cNvSpPr txBox="1"/>
            <p:nvPr/>
          </p:nvSpPr>
          <p:spPr>
            <a:xfrm>
              <a:off x="2542032" y="18288"/>
              <a:ext cx="3962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rPr>
                <a:t>A)</a:t>
              </a:r>
              <a:endParaRPr kumimoji="0" lang="zh-TW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endParaRPr>
            </a:p>
          </p:txBody>
        </p:sp>
      </p:grpSp>
      <p:grpSp>
        <p:nvGrpSpPr>
          <p:cNvPr id="54" name="群組 53"/>
          <p:cNvGrpSpPr/>
          <p:nvPr/>
        </p:nvGrpSpPr>
        <p:grpSpPr>
          <a:xfrm>
            <a:off x="4820793" y="3601814"/>
            <a:ext cx="4974335" cy="3243086"/>
            <a:chOff x="2542032" y="3601814"/>
            <a:chExt cx="4974335" cy="3243086"/>
          </a:xfrm>
        </p:grpSpPr>
        <p:pic>
          <p:nvPicPr>
            <p:cNvPr id="49" name="圖片 48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895401" y="3601814"/>
              <a:ext cx="4620966" cy="1689591"/>
            </a:xfrm>
            <a:prstGeom prst="rect">
              <a:avLst/>
            </a:prstGeom>
          </p:spPr>
        </p:pic>
        <p:pic>
          <p:nvPicPr>
            <p:cNvPr id="50" name="圖片 4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895401" y="5199772"/>
              <a:ext cx="4620966" cy="1645128"/>
            </a:xfrm>
            <a:prstGeom prst="rect">
              <a:avLst/>
            </a:prstGeom>
          </p:spPr>
        </p:pic>
        <p:sp>
          <p:nvSpPr>
            <p:cNvPr id="52" name="文字方塊 51"/>
            <p:cNvSpPr txBox="1"/>
            <p:nvPr/>
          </p:nvSpPr>
          <p:spPr>
            <a:xfrm>
              <a:off x="2542032" y="3627013"/>
              <a:ext cx="3866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TW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新細明體" panose="02020500000000000000" pitchFamily="18" charset="-120"/>
                  <a:cs typeface="+mn-cs"/>
                </a:rPr>
                <a:t>B)</a:t>
              </a:r>
              <a:endParaRPr kumimoji="0" lang="zh-TW" alt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endParaRPr>
            </a:p>
          </p:txBody>
        </p:sp>
      </p:grpSp>
      <p:sp>
        <p:nvSpPr>
          <p:cNvPr id="2" name="矩形 1"/>
          <p:cNvSpPr/>
          <p:nvPr/>
        </p:nvSpPr>
        <p:spPr>
          <a:xfrm>
            <a:off x="685800" y="283682"/>
            <a:ext cx="38862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7200" indent="-457200" algn="just">
              <a:spcAft>
                <a:spcPts val="0"/>
              </a:spcAft>
            </a:pPr>
            <a:r>
              <a:rPr lang="en-US" altLang="zh-TW" b="1" kern="100" dirty="0">
                <a:solidFill>
                  <a:srgbClr val="0000FF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S4 Fig. </a:t>
            </a:r>
            <a:r>
              <a:rPr lang="en-US" altLang="zh-TW" kern="100" dirty="0">
                <a:solidFill>
                  <a:srgbClr val="0000FF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Comparison of pollen grains in microscopic anther sections from WT and </a:t>
            </a:r>
            <a:r>
              <a:rPr lang="en-US" altLang="zh-TW" i="1" kern="100" dirty="0">
                <a:solidFill>
                  <a:srgbClr val="0000FF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osga3ox1</a:t>
            </a:r>
            <a:r>
              <a:rPr lang="en-US" altLang="zh-TW" kern="100" dirty="0">
                <a:solidFill>
                  <a:srgbClr val="0000FF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 variants of different genotypes</a:t>
            </a:r>
            <a:endParaRPr lang="zh-TW" altLang="zh-TW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64654782"/>
      </p:ext>
    </p:extLst>
  </p:cSld>
  <p:clrMapOvr>
    <a:masterClrMapping/>
  </p:clrMapOvr>
</p:sld>
</file>

<file path=ppt/theme/theme1.xml><?xml version="1.0" encoding="utf-8"?>
<a:theme xmlns:a="http://schemas.openxmlformats.org/drawingml/2006/main" name="6_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924</TotalTime>
  <Words>24</Words>
  <Application>Microsoft Office PowerPoint</Application>
  <PresentationFormat>寬螢幕</PresentationFormat>
  <Paragraphs>4</Paragraphs>
  <Slides>1</Slides>
  <Notes>1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7" baseType="lpstr">
      <vt:lpstr>新細明體</vt:lpstr>
      <vt:lpstr>Arial</vt:lpstr>
      <vt:lpstr>Calibri</vt:lpstr>
      <vt:lpstr>Calibri Light</vt:lpstr>
      <vt:lpstr>Times New Roman</vt:lpstr>
      <vt:lpstr>6_Office 佈景主題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RP-OsGA3ox1 T0 Screening</dc:title>
  <dc:creator>陳良築</dc:creator>
  <cp:lastModifiedBy>ljchen</cp:lastModifiedBy>
  <cp:revision>549</cp:revision>
  <cp:lastPrinted>2022-11-05T13:28:51Z</cp:lastPrinted>
  <dcterms:created xsi:type="dcterms:W3CDTF">2021-06-02T06:35:22Z</dcterms:created>
  <dcterms:modified xsi:type="dcterms:W3CDTF">2023-09-27T09:02:13Z</dcterms:modified>
</cp:coreProperties>
</file>